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9906000" cy="6858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9" d="100"/>
          <a:sy n="79" d="100"/>
        </p:scale>
        <p:origin x="44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96FEE-B0B0-4FF0-A745-51C27B051C6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1BED9-6DE8-4E69-B7A5-AA7497FD22E8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68741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96FEE-B0B0-4FF0-A745-51C27B051C6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1BED9-6DE8-4E69-B7A5-AA7497FD22E8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11664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96FEE-B0B0-4FF0-A745-51C27B051C6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1BED9-6DE8-4E69-B7A5-AA7497FD22E8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72836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96FEE-B0B0-4FF0-A745-51C27B051C6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1BED9-6DE8-4E69-B7A5-AA7497FD22E8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43410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96FEE-B0B0-4FF0-A745-51C27B051C6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1BED9-6DE8-4E69-B7A5-AA7497FD22E8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49977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96FEE-B0B0-4FF0-A745-51C27B051C6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1BED9-6DE8-4E69-B7A5-AA7497FD22E8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16735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96FEE-B0B0-4FF0-A745-51C27B051C6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1BED9-6DE8-4E69-B7A5-AA7497FD22E8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96859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96FEE-B0B0-4FF0-A745-51C27B051C6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1BED9-6DE8-4E69-B7A5-AA7497FD22E8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0009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96FEE-B0B0-4FF0-A745-51C27B051C6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1BED9-6DE8-4E69-B7A5-AA7497FD22E8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28849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96FEE-B0B0-4FF0-A745-51C27B051C6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1BED9-6DE8-4E69-B7A5-AA7497FD22E8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41857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96FEE-B0B0-4FF0-A745-51C27B051C6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1BED9-6DE8-4E69-B7A5-AA7497FD22E8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05857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096FEE-B0B0-4FF0-A745-51C27B051C6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41BED9-6DE8-4E69-B7A5-AA7497FD22E8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82845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22762B0E-FABE-78B2-5A32-3996E8E3FE9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2313" y="1060029"/>
            <a:ext cx="4680000" cy="2801500"/>
          </a:xfrm>
          <a:prstGeom prst="rect">
            <a:avLst/>
          </a:prstGeom>
        </p:spPr>
      </p:pic>
      <p:sp>
        <p:nvSpPr>
          <p:cNvPr id="11" name="ZoneTexte 10">
            <a:extLst>
              <a:ext uri="{FF2B5EF4-FFF2-40B4-BE49-F238E27FC236}">
                <a16:creationId xmlns:a16="http://schemas.microsoft.com/office/drawing/2014/main" id="{59E69515-34BC-C28A-9BF1-7455B0A8A687}"/>
              </a:ext>
            </a:extLst>
          </p:cNvPr>
          <p:cNvSpPr txBox="1"/>
          <p:nvPr/>
        </p:nvSpPr>
        <p:spPr>
          <a:xfrm>
            <a:off x="389965" y="690698"/>
            <a:ext cx="2798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etween follow-ups 1 and 2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FC494322-D533-9BD3-626C-5F74329BA335}"/>
              </a:ext>
            </a:extLst>
          </p:cNvPr>
          <p:cNvSpPr txBox="1"/>
          <p:nvPr/>
        </p:nvSpPr>
        <p:spPr>
          <a:xfrm>
            <a:off x="5121998" y="690698"/>
            <a:ext cx="2798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etween follow-ups 1 and 3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6DD888BF-75E6-A22F-F846-363B2C7E0919}"/>
              </a:ext>
            </a:extLst>
          </p:cNvPr>
          <p:cNvSpPr txBox="1"/>
          <p:nvPr/>
        </p:nvSpPr>
        <p:spPr>
          <a:xfrm>
            <a:off x="389965" y="3692959"/>
            <a:ext cx="2798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etween follow-ups 2 and 3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985C1393-DBBC-B3FB-9767-AF801E770074}"/>
              </a:ext>
            </a:extLst>
          </p:cNvPr>
          <p:cNvSpPr txBox="1"/>
          <p:nvPr/>
        </p:nvSpPr>
        <p:spPr>
          <a:xfrm>
            <a:off x="6120000" y="4680000"/>
            <a:ext cx="2843342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dirty="0">
                <a:solidFill>
                  <a:srgbClr val="FF0000"/>
                </a:solidFill>
              </a:rPr>
              <a:t>Weight gain &gt;5 kg</a:t>
            </a:r>
          </a:p>
          <a:p>
            <a:r>
              <a:rPr lang="en-GB" sz="2400" dirty="0"/>
              <a:t>Weight change &lt;5 kg </a:t>
            </a:r>
          </a:p>
          <a:p>
            <a:r>
              <a:rPr lang="en-GB" sz="2400" dirty="0">
                <a:solidFill>
                  <a:srgbClr val="0070C0"/>
                </a:solidFill>
              </a:rPr>
              <a:t>Weight loss &gt;5 kg</a:t>
            </a: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DDE785DA-785A-867D-8481-BB63BBF83708}"/>
              </a:ext>
            </a:extLst>
          </p:cNvPr>
          <p:cNvSpPr txBox="1"/>
          <p:nvPr/>
        </p:nvSpPr>
        <p:spPr>
          <a:xfrm>
            <a:off x="251927" y="19604"/>
            <a:ext cx="927462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spcBef>
                <a:spcPts val="600"/>
              </a:spcBef>
            </a:pPr>
            <a:r>
              <a:rPr lang="en-GB" sz="1800" b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.</a:t>
            </a:r>
            <a:r>
              <a:rPr lang="en-GB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individual 5- and 10-year weight changes among participants with weight misperception.</a:t>
            </a:r>
            <a:endParaRPr lang="fr-CH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Image 6">
            <a:extLst>
              <a:ext uri="{FF2B5EF4-FFF2-40B4-BE49-F238E27FC236}">
                <a16:creationId xmlns:a16="http://schemas.microsoft.com/office/drawing/2014/main" id="{2FD730EA-A76F-5476-D42D-21488BF478E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89241" y="1076125"/>
            <a:ext cx="4680000" cy="2801500"/>
          </a:xfrm>
          <a:prstGeom prst="rect">
            <a:avLst/>
          </a:prstGeom>
        </p:spPr>
      </p:pic>
      <p:pic>
        <p:nvPicPr>
          <p:cNvPr id="9" name="Image 8">
            <a:extLst>
              <a:ext uri="{FF2B5EF4-FFF2-40B4-BE49-F238E27FC236}">
                <a16:creationId xmlns:a16="http://schemas.microsoft.com/office/drawing/2014/main" id="{B54D132F-24CA-604C-169D-04DDC1B23DD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5586" y="4066660"/>
            <a:ext cx="4680000" cy="2801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699606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47</Words>
  <Application>Microsoft Office PowerPoint</Application>
  <PresentationFormat>Format A4 (210 x 297 mm)</PresentationFormat>
  <Paragraphs>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Centre Hospitalier Universitaire Vaudoi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edro Marques-Vidal</dc:creator>
  <cp:lastModifiedBy>Pedro Marques-Vidal</cp:lastModifiedBy>
  <cp:revision>7</cp:revision>
  <dcterms:created xsi:type="dcterms:W3CDTF">2024-10-02T09:01:56Z</dcterms:created>
  <dcterms:modified xsi:type="dcterms:W3CDTF">2025-07-16T06:04:23Z</dcterms:modified>
</cp:coreProperties>
</file>